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06A9CD-B7E1-4653-8190-8D0492DA80A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9243EF-03CB-4838-9F7A-AB2AEB036B5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20F5E7-F2C9-44FB-BA38-EDC917E89BC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6B397E-F302-4A98-B632-A1092727BD1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0488DB-E05B-4797-91CD-B0A4267E477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76AC86-FEAE-4052-983C-6FCEE351D2F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1D6E3A-B074-49FB-A155-E86DE2D619B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95E982-DB51-4D4B-A7F3-5EBFF2E6149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D99AA8-A66A-4711-8C49-75DC4CDCB9C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56C641-5320-4AD9-95E7-3343F935F55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351A54-6EF9-4B6D-8CD7-4AAF3C1C467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3901B4-3DFA-4626-8813-DDCB8043307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DC65490-0B2E-4852-AFA1-4EFF103E27F1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042920" y="1052640"/>
          <a:ext cx="7194600" cy="3733560"/>
        </p:xfrm>
        <a:graphic>
          <a:graphicData uri="http://schemas.openxmlformats.org/drawingml/2006/table">
            <a:tbl>
              <a:tblPr/>
              <a:tblGrid>
                <a:gridCol w="1268640"/>
                <a:gridCol w="2409840"/>
                <a:gridCol w="2428560"/>
                <a:gridCol w="1087560"/>
              </a:tblGrid>
              <a:tr h="371520">
                <a:tc gridSpan="4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imers for cDNA (transcript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9528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mx1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orwar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ver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mplicon siz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base pairs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16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rom exon 2 to 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GAGACCACCTGCTTCTACC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GTGAAATAGGAATTCTGCATG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3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</a:t>
                      </a: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. Exons 1 and 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CGGCATCTTTCTCCTCTTT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CGGTAGAAGCAGGTGGTCT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7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008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3.</a:t>
                      </a:r>
                      <a:r>
                        <a:rPr b="0" lang="es-E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Exons 1 and 3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TGAGACCTCGGCATCTTTCT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CCTCCTTCAGGACAAACTC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7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</a:t>
                      </a: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. Exons 2 and 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GAGACCACCTGCTTCTACC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ACTTGCAAAGGCTCTCCTCA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97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5.</a:t>
                      </a: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Exons 2 and 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ATGAGAAAGAACGGGAGCT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ACCTGAACCACACGGACACT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8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7. </a:t>
                      </a: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xons 4 and 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TGCAGAAAGGTGAGGGAGA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TCTGTTCAATGGCCAGCA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5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8. </a:t>
                      </a: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xons 6 and 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GAACACCCAGAGGCTGACTT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CTTCTGAGGTTGCCAGGAA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7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97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8. </a:t>
                      </a: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xons 7 and 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AGCTGCTGGCCATTGAA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GTGAAATAGGAATTCTGCATG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5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TextBox 2"/>
          <p:cNvSpPr/>
          <p:nvPr/>
        </p:nvSpPr>
        <p:spPr>
          <a:xfrm>
            <a:off x="649440" y="309600"/>
            <a:ext cx="4570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table 2: transcrip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7-12T13:28:25Z</dcterms:created>
  <dc:creator>bl2</dc:creator>
  <dc:description/>
  <dc:language>en-US</dc:language>
  <cp:lastModifiedBy>bl2</cp:lastModifiedBy>
  <dcterms:modified xsi:type="dcterms:W3CDTF">2012-07-12T13:29:07Z</dcterms:modified>
  <cp:revision>1</cp:revision>
  <dc:subject/>
  <dc:title>PowerPoint Presentation</dc:title>
</cp:coreProperties>
</file>